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1880" y="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96720" y="696960"/>
            <a:ext cx="2616120" cy="3487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4BD25C-4A40-46B2-B3AB-F0CA59224B9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768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971880" y="8831160"/>
            <a:ext cx="3036960" cy="46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21047C-0F55-4EFF-8115-E72D1E87376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707AD-4C62-4912-B737-EACCDF6E8D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DF532-AB22-44AC-8BCF-545905EF2D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8BD35-8D09-46F2-B0F7-0AC418C13A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D9B98-A699-4945-A631-ABDF996B0E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5F17C3-2A5F-443D-9C27-10B27C8BA5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46C7B-6202-4818-8492-C67181C6FE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70ECB-7E76-4A96-8D06-5D8E0E845E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F3F8E-678A-43F8-9FF3-C6B6E3BFE3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FAF55-CE76-46E9-B4FD-563B188305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306CFC-414B-4AB8-AACE-F17DF490C2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C2195-914D-471E-8B9D-2EDC4404D9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D81007-3321-4248-B6E2-7A73BE6189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D2BAE2-CD6A-4C30-A972-9A9D91680E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151920" y="44280"/>
            <a:ext cx="6629400" cy="665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Table 3</a:t>
            </a: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EFT and HLA peptide pool sequence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41"/>
          <p:cNvSpPr/>
          <p:nvPr/>
        </p:nvSpPr>
        <p:spPr>
          <a:xfrm>
            <a:off x="368640" y="609480"/>
            <a:ext cx="31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2"/>
          <p:cNvSpPr/>
          <p:nvPr/>
        </p:nvSpPr>
        <p:spPr>
          <a:xfrm>
            <a:off x="363960" y="6702480"/>
            <a:ext cx="3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757080" y="876240"/>
          <a:ext cx="5499360" cy="5591160"/>
        </p:xfrm>
        <a:graphic>
          <a:graphicData uri="http://schemas.openxmlformats.org/drawingml/2006/table">
            <a:tbl>
              <a:tblPr/>
              <a:tblGrid>
                <a:gridCol w="609840"/>
                <a:gridCol w="2120760"/>
                <a:gridCol w="2768760"/>
              </a:tblGrid>
              <a:tr h="19260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eptid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ur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VSDGGPNLY-O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A HLA-A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CTELKLSDY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A HLA-A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GILGFVFT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M HLA-A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GLCTLVAM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BMLF1 HLA-A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NLVPMVATV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CMV pp65 HLA-A2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KTGGPIYKR-O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NP HLA-A68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ILRGSVAH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A HLA-A3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RVRAYTYS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A3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RLRAEAQV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A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IVTDFSVI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A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ATIGTAMY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A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DYCNVLNKEF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RTA HLA-A24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RPPIFIRR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B7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ELRSRYWAI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NP HLA-B8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RAKFKQL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B2LF-1 HLA-B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FLRGRAYG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EBNA 3A HLA-B8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QAKWRLQT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EBNA 3 HLA-B8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SRYWAIRTR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fluenza NP HLA-B27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RRIYDLIEL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EBNA 3C HLA-B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YPLHEQHGM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EBNA 3A HLA-B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EENLLDFVRF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BV HLA-B44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EFFWDANDIY-O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CMV HLA-B44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TPRVTGGGAM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CMV HLA-B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8484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QYIKANSKFIGITEL-O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tanus toxin precursor HLA-Class II, allele undetermined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FNNFTVSFWLRVPKVSASHLE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tanus toxin precursor HLA-DRB1 HLA-DP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332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KFIIKRYTPNNEIDSF-OH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tanus toxin precursor HLA-DR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92600"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-VSIDKFRIFCKALNPK-OH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tanus toxin precursor HLA-DR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2" name="Rectangle 3"/>
          <p:cNvSpPr/>
          <p:nvPr/>
        </p:nvSpPr>
        <p:spPr>
          <a:xfrm>
            <a:off x="380880" y="7467480"/>
            <a:ext cx="601992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EFT and HLA peptide pool sequences. (a) CEFT peptide pool consists of 27 peptides of varying lengths (but mostly 9-mers) encoding for cytomegalovirus (CMV), Epstein-Barr virus (EBV), influenza (Flu), and tetanus toxin. (b) Human leukocyte antigen (HLA) (HLA class I histocompatibility antigen) sequence.  HLA peptide pool consists of 19 peptides that are 15-mer long with 11-mer overlap encoding HLA.  CEFT and HLA peptides were used at 0.1 ug/ml in the in vitro stimulation assay (on days 0 and 11, described in Supplementary Figure 3a) as positive and negative controls, respectively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8"/>
          <p:cNvSpPr/>
          <p:nvPr/>
        </p:nvSpPr>
        <p:spPr>
          <a:xfrm>
            <a:off x="652320" y="6705720"/>
            <a:ext cx="57484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LA Sequence: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PKTHMTHHPI SDHEATLRCW ALGFYPAEIT LTWQRDGEDQ TQDTELVETR PAGDGTFQKW AAVVVPSGEE QRYTCHVQHE GLPKPL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7T18:26:32Z</dcterms:created>
  <dc:creator>Grenga, Italia (NIH/NCI) [F]</dc:creator>
  <dc:description/>
  <dc:language>en-US</dc:language>
  <cp:lastModifiedBy>Weingarten, Debra (NIH/NCI) [E]</cp:lastModifiedBy>
  <cp:lastPrinted>2016-02-29T15:54:00Z</cp:lastPrinted>
  <dcterms:modified xsi:type="dcterms:W3CDTF">2016-04-06T19:08:37Z</dcterms:modified>
  <cp:revision>132</cp:revision>
  <dc:subject/>
  <dc:title>PowerPoint Presentation</dc:title>
</cp:coreProperties>
</file>